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20" r:id="rId2"/>
  </p:sldIdLst>
  <p:sldSz cx="6858000" cy="9144000" type="screen4x3"/>
  <p:notesSz cx="7104063" cy="102346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孝明 平中" initials="孝明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0A0A0"/>
    <a:srgbClr val="FFFFFF"/>
    <a:srgbClr val="575757"/>
    <a:srgbClr val="5E5E5E"/>
    <a:srgbClr val="7B7B7B"/>
    <a:srgbClr val="797979"/>
    <a:srgbClr val="868686"/>
    <a:srgbClr val="646464"/>
    <a:srgbClr val="7E7E7E"/>
    <a:srgbClr val="B0B0B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74" autoAdjust="0"/>
    <p:restoredTop sz="94238" autoAdjust="0"/>
  </p:normalViewPr>
  <p:slideViewPr>
    <p:cSldViewPr snapToGrid="0">
      <p:cViewPr varScale="1">
        <p:scale>
          <a:sx n="115" d="100"/>
          <a:sy n="115" d="100"/>
        </p:scale>
        <p:origin x="102" y="151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427" cy="513508"/>
          </a:xfrm>
          <a:prstGeom prst="rect">
            <a:avLst/>
          </a:prstGeom>
        </p:spPr>
        <p:txBody>
          <a:bodyPr vert="horz" lIns="99075" tIns="49538" rIns="99075" bIns="49538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4023992" y="0"/>
            <a:ext cx="3078427" cy="513508"/>
          </a:xfrm>
          <a:prstGeom prst="rect">
            <a:avLst/>
          </a:prstGeom>
        </p:spPr>
        <p:txBody>
          <a:bodyPr vert="horz" lIns="99075" tIns="49538" rIns="99075" bIns="49538" rtlCol="0"/>
          <a:lstStyle>
            <a:lvl1pPr algn="r">
              <a:defRPr sz="1300"/>
            </a:lvl1pPr>
          </a:lstStyle>
          <a:p>
            <a:fld id="{72D90908-D019-48E4-8077-BA25C8D20D5F}" type="datetimeFigureOut">
              <a:rPr kumimoji="1" lang="ja-JP" altLang="en-US" smtClean="0"/>
              <a:t>2024/6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57425" y="1279525"/>
            <a:ext cx="2589213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75" tIns="49538" rIns="99075" bIns="49538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710407" y="4925407"/>
            <a:ext cx="5683250" cy="4029879"/>
          </a:xfrm>
          <a:prstGeom prst="rect">
            <a:avLst/>
          </a:prstGeom>
        </p:spPr>
        <p:txBody>
          <a:bodyPr vert="horz" lIns="99075" tIns="49538" rIns="99075" bIns="49538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721107"/>
            <a:ext cx="3078427" cy="513507"/>
          </a:xfrm>
          <a:prstGeom prst="rect">
            <a:avLst/>
          </a:prstGeom>
        </p:spPr>
        <p:txBody>
          <a:bodyPr vert="horz" lIns="99075" tIns="49538" rIns="99075" bIns="49538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4023992" y="9721107"/>
            <a:ext cx="3078427" cy="513507"/>
          </a:xfrm>
          <a:prstGeom prst="rect">
            <a:avLst/>
          </a:prstGeom>
        </p:spPr>
        <p:txBody>
          <a:bodyPr vert="horz" lIns="99075" tIns="49538" rIns="99075" bIns="49538" rtlCol="0" anchor="b"/>
          <a:lstStyle>
            <a:lvl1pPr algn="r">
              <a:defRPr sz="1300"/>
            </a:lvl1pPr>
          </a:lstStyle>
          <a:p>
            <a:fld id="{DC8137C5-DBCB-4C8A-845B-62F6194F91F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99916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F9B39-AFC6-42C0-90F7-6FE02029DF94}" type="datetimeFigureOut">
              <a:rPr kumimoji="1" lang="ja-JP" altLang="en-US" smtClean="0"/>
              <a:t>2024/6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344DE-6872-4A52-AEE9-7E16F4B1A0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43440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F9B39-AFC6-42C0-90F7-6FE02029DF94}" type="datetimeFigureOut">
              <a:rPr kumimoji="1" lang="ja-JP" altLang="en-US" smtClean="0"/>
              <a:t>2024/6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344DE-6872-4A52-AEE9-7E16F4B1A0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08008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F9B39-AFC6-42C0-90F7-6FE02029DF94}" type="datetimeFigureOut">
              <a:rPr kumimoji="1" lang="ja-JP" altLang="en-US" smtClean="0"/>
              <a:t>2024/6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344DE-6872-4A52-AEE9-7E16F4B1A0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96435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F9B39-AFC6-42C0-90F7-6FE02029DF94}" type="datetimeFigureOut">
              <a:rPr kumimoji="1" lang="ja-JP" altLang="en-US" smtClean="0"/>
              <a:t>2024/6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344DE-6872-4A52-AEE9-7E16F4B1A0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02111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F9B39-AFC6-42C0-90F7-6FE02029DF94}" type="datetimeFigureOut">
              <a:rPr kumimoji="1" lang="ja-JP" altLang="en-US" smtClean="0"/>
              <a:t>2024/6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344DE-6872-4A52-AEE9-7E16F4B1A0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04464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F9B39-AFC6-42C0-90F7-6FE02029DF94}" type="datetimeFigureOut">
              <a:rPr kumimoji="1" lang="ja-JP" altLang="en-US" smtClean="0"/>
              <a:t>2024/6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344DE-6872-4A52-AEE9-7E16F4B1A0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27250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F9B39-AFC6-42C0-90F7-6FE02029DF94}" type="datetimeFigureOut">
              <a:rPr kumimoji="1" lang="ja-JP" altLang="en-US" smtClean="0"/>
              <a:t>2024/6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344DE-6872-4A52-AEE9-7E16F4B1A0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54305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F9B39-AFC6-42C0-90F7-6FE02029DF94}" type="datetimeFigureOut">
              <a:rPr kumimoji="1" lang="ja-JP" altLang="en-US" smtClean="0"/>
              <a:t>2024/6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344DE-6872-4A52-AEE9-7E16F4B1A0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89376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F9B39-AFC6-42C0-90F7-6FE02029DF94}" type="datetimeFigureOut">
              <a:rPr kumimoji="1" lang="ja-JP" altLang="en-US" smtClean="0"/>
              <a:t>2024/6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344DE-6872-4A52-AEE9-7E16F4B1A0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4356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F9B39-AFC6-42C0-90F7-6FE02029DF94}" type="datetimeFigureOut">
              <a:rPr kumimoji="1" lang="ja-JP" altLang="en-US" smtClean="0"/>
              <a:t>2024/6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344DE-6872-4A52-AEE9-7E16F4B1A0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35809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F9B39-AFC6-42C0-90F7-6FE02029DF94}" type="datetimeFigureOut">
              <a:rPr kumimoji="1" lang="ja-JP" altLang="en-US" smtClean="0"/>
              <a:t>2024/6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344DE-6872-4A52-AEE9-7E16F4B1A0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58313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auto"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FF9B39-AFC6-42C0-90F7-6FE02029DF94}" type="datetimeFigureOut">
              <a:rPr kumimoji="1" lang="ja-JP" altLang="en-US" smtClean="0"/>
              <a:t>2024/6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7344DE-6872-4A52-AEE9-7E16F4B1A0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78268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oogle Shape;88;p13">
            <a:extLst>
              <a:ext uri="{FF2B5EF4-FFF2-40B4-BE49-F238E27FC236}">
                <a16:creationId xmlns:a16="http://schemas.microsoft.com/office/drawing/2014/main" id="{49365373-F5C7-7B90-55C9-A027DE95B86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960553188"/>
              </p:ext>
            </p:extLst>
          </p:nvPr>
        </p:nvGraphicFramePr>
        <p:xfrm>
          <a:off x="171000" y="636754"/>
          <a:ext cx="6516000" cy="304921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3132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920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692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12825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vity</a:t>
                      </a:r>
                      <a:endParaRPr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450" marR="91450" marT="45725" marB="45725" anchor="ctr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  <a:sym typeface="Times New Roman"/>
                        </a:rPr>
                        <a:t>Rehabilitation protocol</a:t>
                      </a:r>
                    </a:p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  <a:sym typeface="Times New Roman"/>
                        </a:rPr>
                        <a:t>April 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  <a:sym typeface="Times New Roman"/>
                        </a:rPr>
                        <a:t>2018-April 2019</a:t>
                      </a:r>
                      <a:endParaRPr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  <a:sym typeface="Times New Roman"/>
                      </a:endParaRPr>
                    </a:p>
                  </a:txBody>
                  <a:tcPr marL="91450" marR="91450" marT="45725" marB="45725" anchor="ctr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200"/>
                        <a:buFont typeface="Times New Roman"/>
                        <a:buNone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  <a:sym typeface="Times New Roman"/>
                        </a:rPr>
                        <a:t>Rehabilitation protocol</a:t>
                      </a:r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200"/>
                        <a:buFont typeface="Times New Roman"/>
                        <a:buNone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  <a:sym typeface="Times New Roman"/>
                        </a:rPr>
                        <a:t>May 2019-October 2021</a:t>
                      </a:r>
                    </a:p>
                  </a:txBody>
                  <a:tcPr marL="91450" marR="91450" marT="45725" marB="45725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200"/>
                        <a:buFont typeface="Times New Roman"/>
                        <a:buNone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Times New Roman"/>
                        </a:rPr>
                        <a:t>Knee immobilization period, daytime</a:t>
                      </a:r>
                      <a:endParaRPr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450" marR="91450" marT="45725" marB="45725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  <a:sym typeface="Times New Roman"/>
                        </a:rPr>
                        <a:t>2 weeks</a:t>
                      </a:r>
                      <a:endParaRPr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  <a:sym typeface="Times New Roman"/>
                      </a:endParaRPr>
                    </a:p>
                  </a:txBody>
                  <a:tcPr marL="91450" marR="91450" marT="45725" marB="45725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  <a:sym typeface="Times New Roman"/>
                        </a:rPr>
                        <a:t>1 weeks</a:t>
                      </a:r>
                      <a:endParaRPr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  <a:sym typeface="Times New Roman"/>
                      </a:endParaRPr>
                    </a:p>
                  </a:txBody>
                  <a:tcPr marL="91450" marR="91450" marT="45725" marB="45725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200"/>
                        <a:buFont typeface="Times New Roman"/>
                        <a:buNone/>
                        <a:tabLst/>
                        <a:defRPr/>
                      </a:pPr>
                      <a:r>
                        <a:rPr lang="en-US" altLang="ja-JP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Times New Roman"/>
                        </a:rPr>
                        <a:t>Knee immobilization period, bedtime</a:t>
                      </a:r>
                      <a:endParaRPr lang="en-US" altLang="ja-JP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450" marR="91450" marT="45725" marB="45725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  <a:sym typeface="Times New Roman"/>
                        </a:rPr>
                        <a:t>4 weeks</a:t>
                      </a:r>
                      <a:endParaRPr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  <a:sym typeface="Times New Roman"/>
                      </a:endParaRPr>
                    </a:p>
                  </a:txBody>
                  <a:tcPr marL="91450" marR="91450" marT="45725" marB="45725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  <a:sym typeface="Times New Roman"/>
                        </a:rPr>
                        <a:t>3 weeks</a:t>
                      </a:r>
                      <a:endParaRPr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  <a:sym typeface="Times New Roman"/>
                      </a:endParaRPr>
                    </a:p>
                  </a:txBody>
                  <a:tcPr marL="91450" marR="91450" marT="45725" marB="45725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7304574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kumimoji="1" lang="en-US" altLang="ja-JP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OM exercises initiation period</a:t>
                      </a:r>
                      <a:endParaRPr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450" marR="91450" marT="45725" marB="45725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200"/>
                        <a:buFont typeface="Times New Roman"/>
                        <a:buNone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Times New Roman"/>
                        </a:rPr>
                        <a:t>P.O. 2 weeks</a:t>
                      </a:r>
                    </a:p>
                  </a:txBody>
                  <a:tcPr marL="91450" marR="91450" marT="45725" marB="45725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altLang="ja-JP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Times New Roman"/>
                        </a:rPr>
                        <a:t>P.O. 1 weeks</a:t>
                      </a:r>
                      <a:endParaRPr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  <a:sym typeface="Times New Roman"/>
                      </a:endParaRPr>
                    </a:p>
                  </a:txBody>
                  <a:tcPr marL="91450" marR="91450" marT="45725" marB="45725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200"/>
                        <a:buFont typeface="Times New Roman"/>
                        <a:buNone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Times New Roman"/>
                        </a:rPr>
                        <a:t>ROM exercises initiation angle</a:t>
                      </a:r>
                      <a:endParaRPr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450" marR="91450" marT="45725" marB="45725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200"/>
                        <a:buFont typeface="Times New Roman"/>
                        <a:buNone/>
                        <a:tabLst/>
                        <a:defRPr/>
                      </a:pPr>
                      <a:r>
                        <a:rPr lang="en-US" altLang="ja-JP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Times New Roman"/>
                        </a:rPr>
                        <a:t>30°</a:t>
                      </a:r>
                    </a:p>
                  </a:txBody>
                  <a:tcPr marL="91450" marR="91450" marT="45725" marB="45725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200"/>
                        <a:buFont typeface="Times New Roman"/>
                        <a:buNone/>
                        <a:tabLst/>
                        <a:defRPr/>
                      </a:pPr>
                      <a:r>
                        <a:rPr lang="en-US" altLang="ja-JP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Times New Roman"/>
                        </a:rPr>
                        <a:t>30°</a:t>
                      </a:r>
                      <a:endParaRPr lang="en-US" altLang="ja-JP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  <a:sym typeface="Times New Roman"/>
                      </a:endParaRPr>
                    </a:p>
                  </a:txBody>
                  <a:tcPr marL="91450" marR="91450" marT="45725" marB="45725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Times New Roman"/>
                        </a:rPr>
                        <a:t>ROM exercises angle increment</a:t>
                      </a:r>
                    </a:p>
                  </a:txBody>
                  <a:tcPr marL="91450" marR="91450" marT="45725" marB="45725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200"/>
                        <a:buFont typeface="Times New Roman"/>
                        <a:buNone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Times New Roman"/>
                        </a:rPr>
                        <a:t>+30°/week</a:t>
                      </a:r>
                      <a:endParaRPr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450" marR="91450" marT="45725" marB="45725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200"/>
                        <a:buFont typeface="Times New Roman"/>
                        <a:buNone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Times New Roman"/>
                        </a:rPr>
                        <a:t>+30°/week</a:t>
                      </a:r>
                      <a:endParaRPr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450" marR="91450" marT="45725" marB="45725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200"/>
                        <a:buFont typeface="Times New Roman"/>
                        <a:buNone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Times New Roman"/>
                        </a:rPr>
                        <a:t>Partial weight bearing (&lt;20kg) initiation period</a:t>
                      </a:r>
                      <a:endParaRPr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450" marR="91450" marT="45725" marB="45725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200"/>
                        <a:buFont typeface="Times New Roman"/>
                        <a:buNone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Times New Roman"/>
                        </a:rPr>
                        <a:t>P.O. 2 weeks</a:t>
                      </a:r>
                    </a:p>
                  </a:txBody>
                  <a:tcPr marL="91450" marR="91450" marT="45725" marB="45725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altLang="ja-JP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Times New Roman"/>
                        </a:rPr>
                        <a:t>P.O. 1 weeks</a:t>
                      </a:r>
                      <a:endParaRPr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Times New Roman"/>
                        <a:cs typeface="Times New Roman" panose="02020603050405020304" pitchFamily="18" charset="0"/>
                        <a:sym typeface="Times New Roman"/>
                      </a:endParaRPr>
                    </a:p>
                  </a:txBody>
                  <a:tcPr marL="91450" marR="91450" marT="45725" marB="45725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200"/>
                        <a:buFont typeface="Times New Roman"/>
                        <a:buNone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Times New Roman"/>
                        </a:rPr>
                        <a:t>Partial weight bearing increment</a:t>
                      </a:r>
                      <a:endParaRPr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450" marR="91450" marT="45725" marB="45725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200"/>
                        <a:buFont typeface="Times New Roman"/>
                        <a:buNone/>
                      </a:pPr>
                      <a:r>
                        <a:rPr lang="en-US" altLang="ja-JP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Times New Roman"/>
                        </a:rPr>
                        <a:t>+20kg/week</a:t>
                      </a:r>
                      <a:endParaRPr lang="en-US" altLang="ja-JP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450" marR="91450" marT="45725" marB="45725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200"/>
                        <a:buFont typeface="Times New Roman"/>
                        <a:buNone/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Times New Roman"/>
                        </a:rPr>
                        <a:t>+20kg/week</a:t>
                      </a:r>
                    </a:p>
                  </a:txBody>
                  <a:tcPr marL="91450" marR="91450" marT="45725" marB="45725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200"/>
                        <a:buFont typeface="Times New Roman"/>
                        <a:buNone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owance of full range of motion</a:t>
                      </a:r>
                      <a:endParaRPr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450" marR="91450" marT="45725" marB="45725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200"/>
                        <a:buFont typeface="Times New Roman"/>
                        <a:buNone/>
                        <a:tabLst/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 month</a:t>
                      </a:r>
                    </a:p>
                  </a:txBody>
                  <a:tcPr marL="91450" marR="91450" marT="45725" marB="45725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200"/>
                        <a:buFont typeface="Times New Roman"/>
                        <a:buNone/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month</a:t>
                      </a:r>
                      <a:endParaRPr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450" marR="91450" marT="45725" marB="45725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81105269"/>
                  </a:ext>
                </a:extLst>
              </a:tr>
            </a:tbl>
          </a:graphicData>
        </a:graphic>
      </p:graphicFrame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AB949E00-B212-12AA-14CA-8741483622C8}"/>
              </a:ext>
            </a:extLst>
          </p:cNvPr>
          <p:cNvSpPr/>
          <p:nvPr/>
        </p:nvSpPr>
        <p:spPr>
          <a:xfrm>
            <a:off x="171000" y="3785577"/>
            <a:ext cx="2942928" cy="2765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defRPr/>
            </a:pPr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ROM, range of motion; P.O., postoperative;</a:t>
            </a:r>
            <a:endParaRPr kumimoji="1" lang="en-US" altLang="ja-JP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" name="Google Shape;89;p13">
            <a:extLst>
              <a:ext uri="{FF2B5EF4-FFF2-40B4-BE49-F238E27FC236}">
                <a16:creationId xmlns:a16="http://schemas.microsoft.com/office/drawing/2014/main" id="{2452B2F7-3F9E-51F1-9D03-C4B033CA2249}"/>
              </a:ext>
            </a:extLst>
          </p:cNvPr>
          <p:cNvSpPr/>
          <p:nvPr/>
        </p:nvSpPr>
        <p:spPr>
          <a:xfrm>
            <a:off x="0" y="102464"/>
            <a:ext cx="6933536" cy="6441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Supplementary Table 1. </a:t>
            </a:r>
            <a:r>
              <a:rPr lang="en-US" altLang="ja-JP" sz="1400" b="1" dirty="0">
                <a:solidFill>
                  <a:prstClr val="black"/>
                </a:solidFill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  <a:sym typeface="Times New Roman"/>
              </a:rPr>
              <a:t>Details about two different rehabilitation protocols.</a:t>
            </a:r>
            <a:endParaRPr kumimoji="1" lang="en-US" altLang="ja-JP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Times New Roman"/>
              <a:cs typeface="Times New Roman" panose="02020603050405020304" pitchFamily="18" charset="0"/>
              <a:sym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6474123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l">
          <a:defRPr kumimoji="1" sz="1000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6</TotalTime>
  <Words>130</Words>
  <Application>Microsoft Office PowerPoint</Application>
  <PresentationFormat>画面に合わせる (4:3)</PresentationFormat>
  <Paragraphs>3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釜付祐輔</dc:creator>
  <cp:lastModifiedBy>優典 田村</cp:lastModifiedBy>
  <cp:revision>798</cp:revision>
  <dcterms:created xsi:type="dcterms:W3CDTF">2017-09-10T08:03:33Z</dcterms:created>
  <dcterms:modified xsi:type="dcterms:W3CDTF">2024-06-05T07:45:50Z</dcterms:modified>
</cp:coreProperties>
</file>